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4"/>
    <p:restoredTop sz="96197"/>
  </p:normalViewPr>
  <p:slideViewPr>
    <p:cSldViewPr snapToGrid="0" snapToObjects="1">
      <p:cViewPr varScale="1">
        <p:scale>
          <a:sx n="128" d="100"/>
          <a:sy n="128" d="100"/>
        </p:scale>
        <p:origin x="1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3F700D-5168-5645-A063-9FEDD2906E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C6BFCA8-3630-C04E-B9DF-7A6538CBD7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D922569-0E37-7B4E-8ADF-E27231022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300D88C-79FA-1F41-814C-415F6FE54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6FA0F9-71CD-824E-9360-B4B2A613A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5016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05A6CFD-0FA6-2F49-8B53-FBBD74C703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CE3E3AC-5600-E94B-BB0D-081BCB6EEB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6C947D3-44DE-464C-8C8B-B714C125C6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56E3DDC-C164-7E40-960C-870BE0C55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8711438-750A-184D-9157-3ED2B1858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3099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0D23C48-FF33-4540-9CFA-44724AF36C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F974CB6-EF2C-CF44-8C9C-9B5C786F19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8883DE-EC37-044A-8B61-870E3542B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D24BBDE-1298-8C4D-944A-0D22F4BC8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71070F5-7F04-5242-8D85-DBAE3F6B28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6188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E995CF7-70C8-0543-A5E7-98922EAB8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F79097D-258E-A042-AE92-EC52B169EC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FE4E038-781A-394B-96C9-0CD38308D5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0897B43-6B6B-8849-AC56-88650316F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73CC30-AAED-A24D-8FAC-164E93A7E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220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5947A4-BE3F-3B40-BF32-AFACE601B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A4ABB9A-1D1A-7241-A1B1-1B7AB65381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0F1A77F-BC38-A34C-A6DD-D9F66467A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CD400E-1508-2D4E-8DCF-B71449E9C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3F45DE0-5066-C945-8BF2-1161A281F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12503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1E01E5-450F-DA45-B8FF-6A2013A53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6E53EDC-7670-CF46-9C2A-421CEDFA55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108790C-193C-1844-BBC6-EB91AAF459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131E069-2050-9C43-8D82-3D9DD042A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017CF80-2E20-8949-9A58-6B5EF5DF5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27FB4D9-6526-FF4C-A93C-18C38B65A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8029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A0052A-EDF0-4349-9E48-FCA90D6D2E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DB8AE4E-5EC2-E64E-95BD-85EE821846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AECBAEC-E9E3-0140-B5CD-3FC2308C89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3AABA5B-42B9-ED48-90E8-9A9DE6DF48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EF6C968C-B7C7-AB46-8CC0-8270414FD1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8B5CC20-BB97-B340-A451-AC0EC40C2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A1AD00B-FEEB-E645-BA95-444FCABFD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7FA74DB5-96F0-F340-A6CF-CF04E5D66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9297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7D821D-03D4-3E4D-9DC9-D5ADEB628C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7C69895-88F5-5D48-9720-8829F1F39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94E7163-4DEE-DD4D-B2AC-97E4D00F7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F4ECFEB-EE72-E041-BF63-C84FE13B2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3434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F257CCD-AAEC-554C-A1C8-EA2AEBAAB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21F3A2D-95D4-584A-8ADC-35ED6E707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21A5A0F-33BE-7B48-AED3-976F59A0B2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6115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436003E-4FA2-6E4C-823E-AA2769367F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195C1D5-D98C-EE41-9525-90AA130BAA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D4E05C9-AA1F-C44B-B675-E53E7DCDD1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D0476F0-6E0B-8D40-A9F8-F61D2E176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30455F7-E7AC-4644-B5C9-96A109794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078527A-90B3-AC4C-96DD-81CEA77BD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9348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CA26143-928D-224A-A9F8-4389D3F56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4D81E589-772C-3446-B43B-48ADE3B063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BFF54FF-C196-DC44-8418-08AB7E370A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2F7CF74-9225-8F4F-8445-A7697148D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0FBE6DE-72B8-D64D-AC08-E411802C5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A4CF354-D004-8A49-B9F1-9AA4EB1DE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6140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3BC4E11-7707-C34D-A848-72EEF9DC5B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3043855-C990-ED4E-8070-D64EE2EDF7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129C5C8-B645-864B-9C0C-1ED8C777FE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CA608-AE3E-D54D-91EE-036F17A66848}" type="datetimeFigureOut">
              <a:rPr lang="fr-FR" smtClean="0"/>
              <a:t>04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322B85C-AC32-BE4F-85CC-4317F9FA20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A070643-727F-C248-86FC-7C71095398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308D6-A1C0-1543-8032-DF680D52627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5875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">
            <a:extLst>
              <a:ext uri="{FF2B5EF4-FFF2-40B4-BE49-F238E27FC236}">
                <a16:creationId xmlns:a16="http://schemas.microsoft.com/office/drawing/2014/main" id="{6370A863-D787-D345-B202-EB78DC8FA4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1474" y="4614545"/>
            <a:ext cx="7200900" cy="86518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45720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900" b="0" i="1" u="none" strike="noStrike" cap="none" normalizeH="0" baseline="0">
                <a:ln>
                  <a:noFill/>
                </a:ln>
                <a:solidFill>
                  <a:srgbClr val="44546A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I: path analysis diagram modelling the relationships between CT types, selected peripheral inflammatory biomarkers, and PANSS factors, adjusted for possible confounding factors; arrows imply significant associations (p-value&lt;0.05); the colour blue represents correlations, while red and orange arrows (paths) depict direct and indirect effects, respectively; the given values correspond to the estimated regression coefficients for each path; asterisks inside the boxes indicate the adjustment factors which also significantly predicted that variable; model fit indices:</a:t>
            </a:r>
            <a:r>
              <a:rPr kumimoji="0" lang="en-GB" altLang="fr-FR" sz="12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kumimoji="0" lang="en-GB" altLang="fr-FR" sz="900" b="0" i="1" u="none" strike="noStrike" cap="none" normalizeH="0" baseline="0">
                <a:ln>
                  <a:noFill/>
                </a:ln>
                <a:solidFill>
                  <a:srgbClr val="44546A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hi-squared=126.86, d.f.=72, p-value=0.91; RMSEA=0.04, p-value=0.89; CFI=0.91; TLI=0.89</a:t>
            </a:r>
            <a:endParaRPr kumimoji="0" lang="en-GB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5" name="Picture 1678284646">
            <a:extLst>
              <a:ext uri="{FF2B5EF4-FFF2-40B4-BE49-F238E27FC236}">
                <a16:creationId xmlns:a16="http://schemas.microsoft.com/office/drawing/2014/main" id="{6EA23AF1-7DB3-EE4D-8957-3749D8420BA2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3994" t="2059" r="4018" b="4868"/>
          <a:stretch/>
        </p:blipFill>
        <p:spPr bwMode="auto">
          <a:xfrm>
            <a:off x="2004786" y="2586037"/>
            <a:ext cx="7534275" cy="31496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Rectangle 3">
            <a:extLst>
              <a:ext uri="{FF2B5EF4-FFF2-40B4-BE49-F238E27FC236}">
                <a16:creationId xmlns:a16="http://schemas.microsoft.com/office/drawing/2014/main" id="{7A645319-49D5-6448-898A-44A14E24C3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2086" y="442916"/>
            <a:ext cx="7835991" cy="6565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25392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2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 Light" panose="02010600030101010101" pitchFamily="2" charset="-122"/>
              </a:rPr>
              <a:t>Supplementary Figure 1: Path analysis model with adjustment factors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Rectangle 5">
            <a:extLst>
              <a:ext uri="{FF2B5EF4-FFF2-40B4-BE49-F238E27FC236}">
                <a16:creationId xmlns:a16="http://schemas.microsoft.com/office/drawing/2014/main" id="{EF788744-848B-6345-98DB-035C1990D8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92086" y="999807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fr-FR" sz="1200" b="0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 lvl="0" indent="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GB" altLang="fr-FR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</a:br>
            <a:endParaRPr kumimoji="0" lang="en-GB" altLang="fr-FR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45720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fr-FR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23597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31</Words>
  <Application>Microsoft Macintosh PowerPoint</Application>
  <PresentationFormat>Grand écran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ptiste Pignon</dc:creator>
  <cp:lastModifiedBy>Baptiste Pignon</cp:lastModifiedBy>
  <cp:revision>4</cp:revision>
  <dcterms:created xsi:type="dcterms:W3CDTF">2024-05-16T12:59:12Z</dcterms:created>
  <dcterms:modified xsi:type="dcterms:W3CDTF">2025-07-04T10:36:05Z</dcterms:modified>
</cp:coreProperties>
</file>